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3" r:id="rId3"/>
  </p:sldIdLst>
  <p:sldSz cx="12192000" cy="6858000"/>
  <p:notesSz cx="7315200" cy="96012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9291FEB-C33F-458B-ABA0-42D0B359D4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97E42F67-0019-40F2-835B-8D56C0B284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AE4E760-A37E-496D-9DD9-302001C42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A2D63BF-0EAE-47F4-8661-3F32162E63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72B4347-8EB6-40C1-B855-30767E2E9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6532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234640-0A38-49C8-88F6-639943278A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85A4717-A5F5-4835-8FF2-A909EAA82B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9DE1F35-FB91-469F-A598-A6741B2CC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12972A1-E14B-415C-8B93-8CAC97BEF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E5716C1-4DA6-4786-9CDC-F7579673E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24428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71E25102-B8C0-434C-A5B7-08E5894917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E1700CC-A5C8-4506-B8F7-F0F1E75252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BECE650-DFC7-4CEF-A328-61526C57C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8A6EECD-9E24-4441-B151-E34F8ACD8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456F473-C38B-47E9-9413-BECDE44CA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4779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53F666C-E796-44B6-83BF-18692A936C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95FE534-7ED7-487A-A822-7B83C0F952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F275D7B-BC04-4121-AC21-146778743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51C5307-81BE-4D55-AB1A-55F8678F3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CAF2434-A476-4958-874A-650579B5AF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84417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C140D51-9AC2-45EC-8EAC-A19DF32FB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4CEE195-7D3F-41D1-ADB0-BEE94A41F9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9C6499F-BA65-4B69-9B67-14FA8F7A7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577393F-B689-483F-8D8D-F0406B4755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B2F4832-D135-4C9F-82AC-8C7C096AE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7418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01B0E2F-6EBC-44C8-9562-53ED6A5DF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AA2EA6C-8896-4AA1-98FA-AEE07999B1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3491E96-BD85-4D82-81F0-D9FF479434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A3A831D-85B7-4EDE-B103-359F0A4BB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EA1F37C-BFFA-4C32-B8E9-1C43C9B5D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590A0AF-3DFC-4D0B-93BA-AFE6C00810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9873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70E5BAF-BAFA-41AA-B072-051457F1F0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4710475-D8D1-4436-B325-5E0AB63320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005C248-54CC-4F67-9000-AB94D97CF9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351724F-2CED-4712-B90E-D3731E248F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DA1B4DF-65AC-45CF-AC27-21304E17FD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930E6DFB-4FC4-412E-BA6E-7C10EE999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3E95D67-6DD5-4DD9-9036-F0E7D1D1B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9E4BEA9-BA46-45F1-AD2C-8C9A55B1F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0985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0D050CD-FFCD-4488-85D2-211ED775B3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93ED378B-A416-4F7B-AEB7-AB916400B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111A0B97-5EE4-4338-A41D-EFCDE5C31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EC9E1853-DE49-4DCB-98D1-FFD88C083C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45524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10A0C285-4E67-4638-8C60-834070F88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50A11DC-7E77-45D7-8923-E5AFBD15E3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736BFE85-AF88-41C9-A37E-10D72137B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1748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7A0DB33-A58E-42CA-B947-5C67F07A8E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EE2D5D3-64C6-4D6D-B393-8A3DE5C2E0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E6AA9B1-73F7-4775-AA8D-EFCA01C339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509F4E1-19FD-4EBF-AFDD-8FCA99959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2E6C9F8-1D18-4692-A3E8-EA0BE50D0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040E51E-A3EF-42CC-B9E6-EDABC6023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8841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41B3B37-1CC9-4175-81FF-8BE5D2D7B0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53FF26E5-5F4B-42DF-9227-2B0938FF27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42F8F8F-D177-472D-A95F-F602E6A00A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F7966FF-B9B7-4B52-B31D-AFB85C5CE9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0FB7C23-1F08-468F-A958-D26FE2F2F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CF20FCD-BAA0-4528-829D-B0FDF27D9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7294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BDD30B7-2B81-4414-BFD3-95A470C4D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401F64E-09F4-4C73-8DAE-13CBD4403F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94E6858-74E7-4FDA-ACAD-DEC4DBAC4C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C82D4-5AE3-429B-9E9C-D629B3C82D07}" type="datetimeFigureOut">
              <a:rPr lang="it-IT" smtClean="0"/>
              <a:t>08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C736356-F71D-477F-B8EE-14A038F5E3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B6BB2D5-AEA7-4FF7-B594-A4A04FBF5C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1A0938-053B-4B95-9AF1-DC7F2410B9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3633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image" Target="../media/image2.png"/><Relationship Id="rId7" Type="http://schemas.openxmlformats.org/officeDocument/2006/relationships/image" Target="../media/image5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emf"/><Relationship Id="rId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3">
            <a:extLst>
              <a:ext uri="{FF2B5EF4-FFF2-40B4-BE49-F238E27FC236}">
                <a16:creationId xmlns:a16="http://schemas.microsoft.com/office/drawing/2014/main" id="{451DA4DF-875A-41A5-81FB-E1A02B00509F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70346" y="3515788"/>
            <a:ext cx="2060595" cy="1402395"/>
            <a:chOff x="-518032" y="431026"/>
            <a:chExt cx="5640594" cy="4319946"/>
          </a:xfrm>
        </p:grpSpPr>
        <p:sp>
          <p:nvSpPr>
            <p:cNvPr id="3" name="CasellaDiTesto 10">
              <a:extLst>
                <a:ext uri="{FF2B5EF4-FFF2-40B4-BE49-F238E27FC236}">
                  <a16:creationId xmlns:a16="http://schemas.microsoft.com/office/drawing/2014/main" id="{07BF3344-972A-4901-BEF3-8FBE5B7F21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52864" y="431026"/>
              <a:ext cx="2443911" cy="6850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/>
              <a:r>
                <a:rPr lang="it-IT" altLang="en-US" sz="800" dirty="0"/>
                <a:t>TNF</a:t>
              </a:r>
              <a:r>
                <a:rPr lang="el-GR" altLang="en-US" sz="800" dirty="0">
                  <a:cs typeface="Calibri" panose="020F0502020204030204" pitchFamily="34" charset="0"/>
                </a:rPr>
                <a:t>α</a:t>
              </a:r>
              <a:endParaRPr lang="en-GB" altLang="en-US" sz="800" dirty="0"/>
            </a:p>
          </p:txBody>
        </p:sp>
        <p:sp>
          <p:nvSpPr>
            <p:cNvPr id="4" name="CasellaDiTesto 15">
              <a:extLst>
                <a:ext uri="{FF2B5EF4-FFF2-40B4-BE49-F238E27FC236}">
                  <a16:creationId xmlns:a16="http://schemas.microsoft.com/office/drawing/2014/main" id="{4B3E449D-B585-4005-BD8E-A6A46DC81C9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8119" y="466346"/>
              <a:ext cx="2469697" cy="6850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/>
              <a:r>
                <a:rPr lang="it-IT" altLang="en-US" sz="800" dirty="0"/>
                <a:t>Control</a:t>
              </a:r>
              <a:endParaRPr lang="en-GB" altLang="en-US" sz="800" dirty="0"/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01103548-CFBD-4B5E-8F25-10F20D07E88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518032" y="1705965"/>
              <a:ext cx="1018433" cy="6850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it-IT" altLang="en-US" sz="800" dirty="0"/>
                <a:t>t0</a:t>
              </a:r>
              <a:endParaRPr lang="en-GB" altLang="en-US" sz="800" dirty="0"/>
            </a:p>
          </p:txBody>
        </p:sp>
        <p:sp>
          <p:nvSpPr>
            <p:cNvPr id="6" name="CasellaDiTesto 17">
              <a:extLst>
                <a:ext uri="{FF2B5EF4-FFF2-40B4-BE49-F238E27FC236}">
                  <a16:creationId xmlns:a16="http://schemas.microsoft.com/office/drawing/2014/main" id="{03223B4E-DDD8-4ECE-BDF6-0A3ED11BB9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512922" y="3686711"/>
              <a:ext cx="992650" cy="6850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it-IT" altLang="en-US" sz="800" dirty="0"/>
                <a:t>t8</a:t>
              </a:r>
              <a:endParaRPr lang="en-GB" altLang="en-US" sz="800" dirty="0"/>
            </a:p>
          </p:txBody>
        </p:sp>
        <p:pic>
          <p:nvPicPr>
            <p:cNvPr id="7" name="Immagine 22">
              <a:extLst>
                <a:ext uri="{FF2B5EF4-FFF2-40B4-BE49-F238E27FC236}">
                  <a16:creationId xmlns:a16="http://schemas.microsoft.com/office/drawing/2014/main" id="{A580B6FF-FFD3-4183-AEF0-11F2824AB87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120" y="930822"/>
              <a:ext cx="2469699" cy="18595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Immagine 25">
              <a:extLst>
                <a:ext uri="{FF2B5EF4-FFF2-40B4-BE49-F238E27FC236}">
                  <a16:creationId xmlns:a16="http://schemas.microsoft.com/office/drawing/2014/main" id="{2B1D6DF5-134B-4CAB-BDD6-5E9ADF08F81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27075" y="944770"/>
              <a:ext cx="2469699" cy="18595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Immagine 27">
              <a:extLst>
                <a:ext uri="{FF2B5EF4-FFF2-40B4-BE49-F238E27FC236}">
                  <a16:creationId xmlns:a16="http://schemas.microsoft.com/office/drawing/2014/main" id="{C76F1036-2BDA-4360-B1A7-B764AF989AC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119" y="2891435"/>
              <a:ext cx="2469699" cy="18595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Immagine 29">
              <a:extLst>
                <a:ext uri="{FF2B5EF4-FFF2-40B4-BE49-F238E27FC236}">
                  <a16:creationId xmlns:a16="http://schemas.microsoft.com/office/drawing/2014/main" id="{47C88F60-FA99-4992-BF61-7C2859A6B84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52863" y="2891434"/>
              <a:ext cx="2469699" cy="18595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aphicFrame>
        <p:nvGraphicFramePr>
          <p:cNvPr id="11" name="Oggetto 2">
            <a:extLst>
              <a:ext uri="{FF2B5EF4-FFF2-40B4-BE49-F238E27FC236}">
                <a16:creationId xmlns:a16="http://schemas.microsoft.com/office/drawing/2014/main" id="{5016394B-14F5-4DF6-9994-A749593AE3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9929480"/>
              </p:ext>
            </p:extLst>
          </p:nvPr>
        </p:nvGraphicFramePr>
        <p:xfrm>
          <a:off x="2780989" y="3492815"/>
          <a:ext cx="2265705" cy="15236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6" imgW="3781080" imgH="2647080" progId="Prism5.Document">
                  <p:embed/>
                </p:oleObj>
              </mc:Choice>
              <mc:Fallback>
                <p:oleObj name="Prism 5" r:id="rId6" imgW="3781080" imgH="2647080" progId="Prism5.Document">
                  <p:embed/>
                  <p:pic>
                    <p:nvPicPr>
                      <p:cNvPr id="6" name="Oggetto 2">
                        <a:extLst>
                          <a:ext uri="{FF2B5EF4-FFF2-40B4-BE49-F238E27FC236}">
                            <a16:creationId xmlns:a16="http://schemas.microsoft.com/office/drawing/2014/main" id="{138A2097-E9FE-4FFA-B586-3C28F528A18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80989" y="3492815"/>
                        <a:ext cx="2265705" cy="152361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8BF765AE-B616-4A9B-A518-10ED1A656676}"/>
              </a:ext>
            </a:extLst>
          </p:cNvPr>
          <p:cNvSpPr txBox="1"/>
          <p:nvPr/>
        </p:nvSpPr>
        <p:spPr>
          <a:xfrm>
            <a:off x="2946730" y="1661572"/>
            <a:ext cx="1972101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/>
              <a:t>Figure 1S- MTT vitality assay</a:t>
            </a:r>
            <a:r>
              <a:rPr lang="en-GB" sz="900" dirty="0"/>
              <a:t>. HUVEC were treated with TNF</a:t>
            </a:r>
            <a:r>
              <a:rPr lang="el-GR" sz="900" dirty="0"/>
              <a:t>α </a:t>
            </a:r>
            <a:r>
              <a:rPr lang="en-GB" sz="900" dirty="0"/>
              <a:t>and cell viability was assessed by MTT assay after 6, 16, 24, and 48 hours. Values represent mean ± </a:t>
            </a:r>
            <a:r>
              <a:rPr lang="en-US" sz="900" dirty="0"/>
              <a:t>S.E</a:t>
            </a:r>
            <a:r>
              <a:rPr lang="en-GB" sz="900" dirty="0"/>
              <a:t>.M. (n=2).</a:t>
            </a:r>
            <a:endParaRPr lang="en-US" sz="900" dirty="0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777086C2-9A42-41DA-9724-6CFCBEA348BA}"/>
              </a:ext>
            </a:extLst>
          </p:cNvPr>
          <p:cNvSpPr txBox="1"/>
          <p:nvPr/>
        </p:nvSpPr>
        <p:spPr>
          <a:xfrm>
            <a:off x="482890" y="5305052"/>
            <a:ext cx="45638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/>
              <a:t>Figure 2S- Wound healing assay of HUVEC. </a:t>
            </a:r>
            <a:r>
              <a:rPr lang="en-GB" sz="900" dirty="0"/>
              <a:t>The assay was conducted in HUVEC treated with TNF</a:t>
            </a:r>
            <a:r>
              <a:rPr lang="el-GR" sz="900" dirty="0"/>
              <a:t>α </a:t>
            </a:r>
            <a:r>
              <a:rPr lang="en-GB" sz="900" dirty="0"/>
              <a:t>and control cells. Representative photographs were taken at 0 h and 8 h post-wound ( × 40) and the wound closure was quantified at 0, 2, 4, 6 and 8 hours post-wound by measuring the remaining unmigrated area using ImageJ. Values represent mean ± </a:t>
            </a:r>
            <a:r>
              <a:rPr lang="en-US" sz="900" dirty="0"/>
              <a:t>S.E.M.</a:t>
            </a:r>
            <a:r>
              <a:rPr lang="en-GB" sz="900" dirty="0"/>
              <a:t> (n=3).</a:t>
            </a:r>
            <a:endParaRPr lang="en-US" sz="900" dirty="0"/>
          </a:p>
        </p:txBody>
      </p:sp>
      <p:graphicFrame>
        <p:nvGraphicFramePr>
          <p:cNvPr id="14" name="Oggetto 13">
            <a:extLst>
              <a:ext uri="{FF2B5EF4-FFF2-40B4-BE49-F238E27FC236}">
                <a16:creationId xmlns:a16="http://schemas.microsoft.com/office/drawing/2014/main" id="{A9A6D809-92A1-4944-8D45-80EC311ADA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4515278"/>
              </p:ext>
            </p:extLst>
          </p:nvPr>
        </p:nvGraphicFramePr>
        <p:xfrm>
          <a:off x="518874" y="1330780"/>
          <a:ext cx="2525339" cy="16130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8" imgW="4649760" imgH="2971800" progId="Prism5.Document">
                  <p:embed/>
                </p:oleObj>
              </mc:Choice>
              <mc:Fallback>
                <p:oleObj name="Prism 5" r:id="rId8" imgW="4649760" imgH="2971800" progId="Prism5.Document">
                  <p:embed/>
                  <p:pic>
                    <p:nvPicPr>
                      <p:cNvPr id="4" name="Oggetto 3">
                        <a:extLst>
                          <a:ext uri="{FF2B5EF4-FFF2-40B4-BE49-F238E27FC236}">
                            <a16:creationId xmlns:a16="http://schemas.microsoft.com/office/drawing/2014/main" id="{D3451A09-9920-4BDB-A74C-620F5EAD80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18874" y="1330780"/>
                        <a:ext cx="2525339" cy="16130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9F90EDD6-2C35-45C7-88FD-CDAF425AAC42}"/>
              </a:ext>
            </a:extLst>
          </p:cNvPr>
          <p:cNvSpPr txBox="1"/>
          <p:nvPr/>
        </p:nvSpPr>
        <p:spPr>
          <a:xfrm>
            <a:off x="1590347" y="490330"/>
            <a:ext cx="23039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Supplemental</a:t>
            </a:r>
            <a:r>
              <a:rPr lang="it-IT" dirty="0"/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12281428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68FF20C-E632-4D1A-921C-92C8C3655D36}"/>
              </a:ext>
            </a:extLst>
          </p:cNvPr>
          <p:cNvSpPr txBox="1"/>
          <p:nvPr/>
        </p:nvSpPr>
        <p:spPr>
          <a:xfrm rot="10800000" flipV="1">
            <a:off x="496276" y="2135181"/>
            <a:ext cx="450336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/>
              <a:t>Figure 3S - E</a:t>
            </a:r>
            <a:r>
              <a:rPr lang="en-US" sz="900" b="1" dirty="0" err="1"/>
              <a:t>xpression</a:t>
            </a:r>
            <a:r>
              <a:rPr lang="en-US" sz="900" b="1" dirty="0"/>
              <a:t> levels of </a:t>
            </a:r>
            <a:r>
              <a:rPr lang="en-US" sz="900" b="1" dirty="0" err="1"/>
              <a:t>syndecans</a:t>
            </a:r>
            <a:r>
              <a:rPr lang="en-US" sz="900" b="1" dirty="0"/>
              <a:t> chains biosynthetic enzyme</a:t>
            </a:r>
            <a:r>
              <a:rPr lang="en-US" sz="900" dirty="0"/>
              <a:t>. EXT1 and EXT2 are involved in chains elongation while NDST1 acts in chains modification and maturation. Using RT-PCR analysis the transcription levels of EXT1, EXT2 and NDST1 were examined in HUVEC control and stimulated with TNF</a:t>
            </a:r>
            <a:r>
              <a:rPr lang="el-GR" sz="900" dirty="0"/>
              <a:t>α</a:t>
            </a:r>
            <a:r>
              <a:rPr lang="it-IT" sz="900" dirty="0"/>
              <a:t> for 24 hours. </a:t>
            </a:r>
            <a:r>
              <a:rPr lang="en-GB" sz="900" dirty="0"/>
              <a:t>Values represent mean ± S.E.M. (n=3), *** p&lt;0,001.</a:t>
            </a:r>
          </a:p>
        </p:txBody>
      </p:sp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2037AC84-2CF8-47EA-AEBF-429515504F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7128003"/>
              </p:ext>
            </p:extLst>
          </p:nvPr>
        </p:nvGraphicFramePr>
        <p:xfrm>
          <a:off x="1477963" y="649281"/>
          <a:ext cx="2339975" cy="1485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4311360" imgH="2737080" progId="Prism5.Document">
                  <p:embed/>
                </p:oleObj>
              </mc:Choice>
              <mc:Fallback>
                <p:oleObj name="Prism 5" r:id="rId2" imgW="4311360" imgH="2737080" progId="Prism5.Document">
                  <p:embed/>
                  <p:pic>
                    <p:nvPicPr>
                      <p:cNvPr id="3" name="Oggetto 2">
                        <a:extLst>
                          <a:ext uri="{FF2B5EF4-FFF2-40B4-BE49-F238E27FC236}">
                            <a16:creationId xmlns:a16="http://schemas.microsoft.com/office/drawing/2014/main" id="{899C0D38-A365-4EE0-AC57-CABAF48401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77963" y="649281"/>
                        <a:ext cx="2339975" cy="1485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05F553E0-5696-4F85-A910-B6D61F7B66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1771569"/>
              </p:ext>
            </p:extLst>
          </p:nvPr>
        </p:nvGraphicFramePr>
        <p:xfrm>
          <a:off x="1477963" y="3309938"/>
          <a:ext cx="2446337" cy="152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4" imgW="4851000" imgH="3031200" progId="Prism5.Document">
                  <p:embed/>
                </p:oleObj>
              </mc:Choice>
              <mc:Fallback>
                <p:oleObj name="Prism 5" r:id="rId4" imgW="4851000" imgH="3031200" progId="Prism5.Document">
                  <p:embed/>
                  <p:pic>
                    <p:nvPicPr>
                      <p:cNvPr id="4" name="Oggetto 3">
                        <a:extLst>
                          <a:ext uri="{FF2B5EF4-FFF2-40B4-BE49-F238E27FC236}">
                            <a16:creationId xmlns:a16="http://schemas.microsoft.com/office/drawing/2014/main" id="{2CEB2DE5-F237-4ACF-9DDE-C946E6F209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477963" y="3309938"/>
                        <a:ext cx="2446337" cy="152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CasellaDiTesto 8">
            <a:extLst>
              <a:ext uri="{FF2B5EF4-FFF2-40B4-BE49-F238E27FC236}">
                <a16:creationId xmlns:a16="http://schemas.microsoft.com/office/drawing/2014/main" id="{66F8370E-EABB-443D-807E-7A5BFC8E6021}"/>
              </a:ext>
            </a:extLst>
          </p:cNvPr>
          <p:cNvSpPr txBox="1"/>
          <p:nvPr/>
        </p:nvSpPr>
        <p:spPr>
          <a:xfrm rot="10800000" flipV="1">
            <a:off x="496276" y="5097452"/>
            <a:ext cx="45033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/>
              <a:t>Figure 4S– GAGs quantification.</a:t>
            </a:r>
            <a:r>
              <a:rPr lang="en-GB" sz="900" dirty="0"/>
              <a:t> </a:t>
            </a:r>
            <a:r>
              <a:rPr lang="en-US" sz="900" dirty="0"/>
              <a:t>HS GAGs extracted </a:t>
            </a:r>
            <a:r>
              <a:rPr lang="it-IT" sz="900" dirty="0"/>
              <a:t>from </a:t>
            </a:r>
            <a:r>
              <a:rPr lang="en-GB" sz="900" dirty="0"/>
              <a:t>conditioned medium and plasma membrane of HUVEC control and treated 24 hour with TNF</a:t>
            </a:r>
            <a:r>
              <a:rPr lang="el-GR" sz="9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it-IT" sz="90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were used </a:t>
            </a:r>
            <a:r>
              <a:rPr lang="it-IT" sz="900" dirty="0">
                <a:latin typeface="Calibri" panose="020F0502020204030204" pitchFamily="34" charset="0"/>
                <a:cs typeface="Calibri" panose="020F0502020204030204" pitchFamily="34" charset="0"/>
              </a:rPr>
              <a:t>to</a:t>
            </a:r>
            <a:r>
              <a:rPr lang="en-GB" sz="900" dirty="0"/>
              <a:t> measure the concentration of glucuronic acid as detector of HS quantity. Data are mean ± S.E.M. of three independents experiments.</a:t>
            </a:r>
          </a:p>
        </p:txBody>
      </p:sp>
    </p:spTree>
    <p:extLst>
      <p:ext uri="{BB962C8B-B14F-4D97-AF65-F5344CB8AC3E}">
        <p14:creationId xmlns:p14="http://schemas.microsoft.com/office/powerpoint/2010/main" val="300251460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4</Words>
  <Application>Microsoft Office PowerPoint</Application>
  <PresentationFormat>Widescreen</PresentationFormat>
  <Paragraphs>9</Paragraphs>
  <Slides>2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ism 5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nuela viola</dc:creator>
  <cp:lastModifiedBy>manuela viola</cp:lastModifiedBy>
  <cp:revision>8</cp:revision>
  <cp:lastPrinted>2021-02-08T18:08:18Z</cp:lastPrinted>
  <dcterms:created xsi:type="dcterms:W3CDTF">2020-11-06T11:47:20Z</dcterms:created>
  <dcterms:modified xsi:type="dcterms:W3CDTF">2021-02-08T18:42:16Z</dcterms:modified>
</cp:coreProperties>
</file>